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6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堀 輝" userId="e8ea494b372a5451" providerId="LiveId" clId="{2FF9C1AC-88A6-42BF-B49C-20B774E33564}"/>
    <pc:docChg chg="custSel addSld delSld modSld sldOrd">
      <pc:chgData name="堀 輝" userId="e8ea494b372a5451" providerId="LiveId" clId="{2FF9C1AC-88A6-42BF-B49C-20B774E33564}" dt="2022-03-22T09:42:00.952" v="257" actId="20577"/>
      <pc:docMkLst>
        <pc:docMk/>
      </pc:docMkLst>
      <pc:sldChg chg="addSp delSp modSp mod">
        <pc:chgData name="堀 輝" userId="e8ea494b372a5451" providerId="LiveId" clId="{2FF9C1AC-88A6-42BF-B49C-20B774E33564}" dt="2022-03-14T01:29:31.934" v="256" actId="20577"/>
        <pc:sldMkLst>
          <pc:docMk/>
          <pc:sldMk cId="82534051" sldId="256"/>
        </pc:sldMkLst>
        <pc:spChg chg="mod">
          <ac:chgData name="堀 輝" userId="e8ea494b372a5451" providerId="LiveId" clId="{2FF9C1AC-88A6-42BF-B49C-20B774E33564}" dt="2022-03-14T01:29:31.934" v="256" actId="20577"/>
          <ac:spMkLst>
            <pc:docMk/>
            <pc:sldMk cId="82534051" sldId="256"/>
            <ac:spMk id="5" creationId="{585F7567-ED5E-432B-B9E8-AD3E7C0470D8}"/>
          </ac:spMkLst>
        </pc:spChg>
        <pc:graphicFrameChg chg="add mod modGraphic">
          <ac:chgData name="堀 輝" userId="e8ea494b372a5451" providerId="LiveId" clId="{2FF9C1AC-88A6-42BF-B49C-20B774E33564}" dt="2022-03-14T00:22:24.168" v="185"/>
          <ac:graphicFrameMkLst>
            <pc:docMk/>
            <pc:sldMk cId="82534051" sldId="256"/>
            <ac:graphicFrameMk id="2" creationId="{3F2FDC1B-20CD-447E-8276-77221D45FBC6}"/>
          </ac:graphicFrameMkLst>
        </pc:graphicFrameChg>
        <pc:graphicFrameChg chg="del">
          <ac:chgData name="堀 輝" userId="e8ea494b372a5451" providerId="LiveId" clId="{2FF9C1AC-88A6-42BF-B49C-20B774E33564}" dt="2022-03-14T00:16:19.667" v="133" actId="478"/>
          <ac:graphicFrameMkLst>
            <pc:docMk/>
            <pc:sldMk cId="82534051" sldId="256"/>
            <ac:graphicFrameMk id="4" creationId="{29E981D5-5E06-4FB9-92FC-4E85D934D278}"/>
          </ac:graphicFrameMkLst>
        </pc:graphicFrameChg>
      </pc:sldChg>
      <pc:sldChg chg="addSp delSp modSp new del mod">
        <pc:chgData name="堀 輝" userId="e8ea494b372a5451" providerId="LiveId" clId="{2FF9C1AC-88A6-42BF-B49C-20B774E33564}" dt="2022-03-14T00:08:37.935" v="44" actId="2696"/>
        <pc:sldMkLst>
          <pc:docMk/>
          <pc:sldMk cId="768209456" sldId="257"/>
        </pc:sldMkLst>
        <pc:spChg chg="del">
          <ac:chgData name="堀 輝" userId="e8ea494b372a5451" providerId="LiveId" clId="{2FF9C1AC-88A6-42BF-B49C-20B774E33564}" dt="2022-03-14T00:03:29.773" v="3" actId="478"/>
          <ac:spMkLst>
            <pc:docMk/>
            <pc:sldMk cId="768209456" sldId="257"/>
            <ac:spMk id="2" creationId="{2FB6FFE8-A7B4-4B16-9735-38CFE92C27E3}"/>
          </ac:spMkLst>
        </pc:spChg>
        <pc:spChg chg="del">
          <ac:chgData name="堀 輝" userId="e8ea494b372a5451" providerId="LiveId" clId="{2FF9C1AC-88A6-42BF-B49C-20B774E33564}" dt="2022-03-14T00:03:26.100" v="1" actId="478"/>
          <ac:spMkLst>
            <pc:docMk/>
            <pc:sldMk cId="768209456" sldId="257"/>
            <ac:spMk id="3" creationId="{AAD83E25-4347-4E23-B4A9-56F8CED2ED6D}"/>
          </ac:spMkLst>
        </pc:spChg>
        <pc:spChg chg="add mod">
          <ac:chgData name="堀 輝" userId="e8ea494b372a5451" providerId="LiveId" clId="{2FF9C1AC-88A6-42BF-B49C-20B774E33564}" dt="2022-03-14T00:06:51.014" v="22"/>
          <ac:spMkLst>
            <pc:docMk/>
            <pc:sldMk cId="768209456" sldId="257"/>
            <ac:spMk id="5" creationId="{A985EC96-D625-404C-A9BF-5207891BB333}"/>
          </ac:spMkLst>
        </pc:spChg>
        <pc:graphicFrameChg chg="add mod modGraphic">
          <ac:chgData name="堀 輝" userId="e8ea494b372a5451" providerId="LiveId" clId="{2FF9C1AC-88A6-42BF-B49C-20B774E33564}" dt="2022-03-14T00:04:33.397" v="21" actId="14734"/>
          <ac:graphicFrameMkLst>
            <pc:docMk/>
            <pc:sldMk cId="768209456" sldId="257"/>
            <ac:graphicFrameMk id="4" creationId="{31C374A8-3F59-4D00-9ACB-DC022EAECC95}"/>
          </ac:graphicFrameMkLst>
        </pc:graphicFrameChg>
      </pc:sldChg>
      <pc:sldChg chg="addSp delSp modSp new mod ord">
        <pc:chgData name="堀 輝" userId="e8ea494b372a5451" providerId="LiveId" clId="{2FF9C1AC-88A6-42BF-B49C-20B774E33564}" dt="2022-03-22T09:42:00.952" v="257" actId="20577"/>
        <pc:sldMkLst>
          <pc:docMk/>
          <pc:sldMk cId="3947097" sldId="258"/>
        </pc:sldMkLst>
        <pc:spChg chg="del">
          <ac:chgData name="堀 輝" userId="e8ea494b372a5451" providerId="LiveId" clId="{2FF9C1AC-88A6-42BF-B49C-20B774E33564}" dt="2022-03-14T00:07:22.519" v="25" actId="478"/>
          <ac:spMkLst>
            <pc:docMk/>
            <pc:sldMk cId="3947097" sldId="258"/>
            <ac:spMk id="2" creationId="{240D744C-8ACF-494B-A847-E53BE40B71D9}"/>
          </ac:spMkLst>
        </pc:spChg>
        <pc:spChg chg="del">
          <ac:chgData name="堀 輝" userId="e8ea494b372a5451" providerId="LiveId" clId="{2FF9C1AC-88A6-42BF-B49C-20B774E33564}" dt="2022-03-14T00:07:20.907" v="24"/>
          <ac:spMkLst>
            <pc:docMk/>
            <pc:sldMk cId="3947097" sldId="258"/>
            <ac:spMk id="3" creationId="{C5D95B56-3D73-48E9-BFC6-63DDA809EC1B}"/>
          </ac:spMkLst>
        </pc:spChg>
        <pc:spChg chg="add del mod">
          <ac:chgData name="堀 輝" userId="e8ea494b372a5451" providerId="LiveId" clId="{2FF9C1AC-88A6-42BF-B49C-20B774E33564}" dt="2022-03-14T00:09:42.006" v="53" actId="478"/>
          <ac:spMkLst>
            <pc:docMk/>
            <pc:sldMk cId="3947097" sldId="258"/>
            <ac:spMk id="6" creationId="{E65FFFB4-6D52-4067-A2D1-F6DB88566D3D}"/>
          </ac:spMkLst>
        </pc:spChg>
        <pc:spChg chg="add mod">
          <ac:chgData name="堀 輝" userId="e8ea494b372a5451" providerId="LiveId" clId="{2FF9C1AC-88A6-42BF-B49C-20B774E33564}" dt="2022-03-14T01:29:27.347" v="254" actId="20577"/>
          <ac:spMkLst>
            <pc:docMk/>
            <pc:sldMk cId="3947097" sldId="258"/>
            <ac:spMk id="7" creationId="{60AF4B24-E1D9-4A49-B410-BD5FD417161E}"/>
          </ac:spMkLst>
        </pc:spChg>
        <pc:graphicFrameChg chg="add mod modGraphic">
          <ac:chgData name="堀 輝" userId="e8ea494b372a5451" providerId="LiveId" clId="{2FF9C1AC-88A6-42BF-B49C-20B774E33564}" dt="2022-03-22T09:42:00.952" v="257" actId="20577"/>
          <ac:graphicFrameMkLst>
            <pc:docMk/>
            <pc:sldMk cId="3947097" sldId="258"/>
            <ac:graphicFrameMk id="4" creationId="{798BEF20-1EB7-474D-A29C-6A31978F3128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AC1F5E3-E3A4-49D6-998A-9CF750A2D0A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AD06E33D-5267-4BB1-A168-8B43D2282A9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AB44AB3-88A0-4F2D-82DF-C0CEBD9969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B3624F-0771-4BFC-893F-5FA64BEFACAA}" type="datetimeFigureOut">
              <a:rPr kumimoji="1" lang="ja-JP" altLang="en-US" smtClean="0"/>
              <a:t>2022/3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1C41F0C-3862-40A2-8550-881DB1CF8A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020ABB9-0B40-485C-BD6C-53FFDD1EFA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42898-05B2-4BEA-BD12-7BF21AF849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42694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DE75EE7-0A4B-4D02-8602-0627C85817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FF94995-5F70-4C3E-95EE-A8A102099E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2EB19F9-7991-4061-BAA9-0340454AF9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B3624F-0771-4BFC-893F-5FA64BEFACAA}" type="datetimeFigureOut">
              <a:rPr kumimoji="1" lang="ja-JP" altLang="en-US" smtClean="0"/>
              <a:t>2022/3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3C600EB-6770-49E6-BD7D-B06E6A98D8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29A3283-3F58-4BEA-87BA-218CC19592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42898-05B2-4BEA-BD12-7BF21AF849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61881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52A08B8-9D1F-460F-AB10-FCBABAC4661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0CB1F81-64A1-495E-BD8C-DC2B877AFF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55125C4-9164-4925-97E8-1FDB241F7A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B3624F-0771-4BFC-893F-5FA64BEFACAA}" type="datetimeFigureOut">
              <a:rPr kumimoji="1" lang="ja-JP" altLang="en-US" smtClean="0"/>
              <a:t>2022/3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2DD0FD3-1B82-4289-85E9-3714271739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F7A8DAF-2601-4599-8D97-6945DFFBE7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42898-05B2-4BEA-BD12-7BF21AF849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96968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1303758-6CB2-4899-95E3-25D5A2A436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16387CD-E127-4613-8F1E-2293C7ECF56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F614485-9800-4F02-81EF-FE6B68B742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B3624F-0771-4BFC-893F-5FA64BEFACAA}" type="datetimeFigureOut">
              <a:rPr kumimoji="1" lang="ja-JP" altLang="en-US" smtClean="0"/>
              <a:t>2022/3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BF41707-D38C-4D7A-8A19-64C09215E7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5FB474B-D8B5-49F3-9F6A-F9BA3F2428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42898-05B2-4BEA-BD12-7BF21AF849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79600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4A9FA97-B8FE-4C0B-8BCE-6A8599BC84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852C763-5649-4395-B24D-624FD0532C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699A18E-AF9C-422E-A055-2CAFA278C9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B3624F-0771-4BFC-893F-5FA64BEFACAA}" type="datetimeFigureOut">
              <a:rPr kumimoji="1" lang="ja-JP" altLang="en-US" smtClean="0"/>
              <a:t>2022/3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EE2FA9D-BD24-4F8E-897C-630B7EB537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AE903F7-E968-4145-A61E-634CB13BC3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42898-05B2-4BEA-BD12-7BF21AF849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53722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2B537D6-915D-4402-A696-BD540F4709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584AE8D-90D9-4168-B94D-1A083C9191B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E848E64-A07F-4DE8-AC5B-3A5C4BA7AC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BA3974A-EEE7-4E8D-B8B0-25D72AD878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B3624F-0771-4BFC-893F-5FA64BEFACAA}" type="datetimeFigureOut">
              <a:rPr kumimoji="1" lang="ja-JP" altLang="en-US" smtClean="0"/>
              <a:t>2022/3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482916D-9D1E-43F7-8687-260883EB5E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B92F17F-81BA-4E8E-AAE1-AEB2D46B7D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42898-05B2-4BEA-BD12-7BF21AF849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31514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95F66F9-F3C3-4FCB-A922-83204DDE62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57E6AD7-C155-49D5-9238-E5E6FD21AE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620DAD0-75FD-43EC-A18A-11DFBA913B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FE40DBA-2A55-4BDA-9F98-A181B72F362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F5AB8DEB-6E54-4786-98AF-2D59C6BDA22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38FF1BFD-BA02-425E-8604-810AB04512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B3624F-0771-4BFC-893F-5FA64BEFACAA}" type="datetimeFigureOut">
              <a:rPr kumimoji="1" lang="ja-JP" altLang="en-US" smtClean="0"/>
              <a:t>2022/3/2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99A1F088-6291-4CD5-A6A8-6AA0F1749A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D3B21478-C8D7-4242-9969-960A21F282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42898-05B2-4BEA-BD12-7BF21AF849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82546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6557501-899A-4652-B883-2E65151529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F454B348-B2C6-4BBF-AC5E-77118F616A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B3624F-0771-4BFC-893F-5FA64BEFACAA}" type="datetimeFigureOut">
              <a:rPr kumimoji="1" lang="ja-JP" altLang="en-US" smtClean="0"/>
              <a:t>2022/3/2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9188C00-6537-461E-8037-62797F27B8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21FDA35A-D0F7-4162-BB68-597D33D21C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42898-05B2-4BEA-BD12-7BF21AF849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78327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1E6B3960-FE0F-45EA-BC87-2BA292A846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B3624F-0771-4BFC-893F-5FA64BEFACAA}" type="datetimeFigureOut">
              <a:rPr kumimoji="1" lang="ja-JP" altLang="en-US" smtClean="0"/>
              <a:t>2022/3/2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A64EDBD-8350-43D0-A541-3C7277F6D1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4851AF52-F19F-4A42-823A-4E861C5622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42898-05B2-4BEA-BD12-7BF21AF849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40270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87541E5-3D99-476E-818E-0D2DA61F59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E7EBFA5-40D9-4308-B9A2-A4D8F85802B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3BD2362-592F-42ED-921A-9E49A43EA5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561638F-905E-4B52-B5DB-7588AB6837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B3624F-0771-4BFC-893F-5FA64BEFACAA}" type="datetimeFigureOut">
              <a:rPr kumimoji="1" lang="ja-JP" altLang="en-US" smtClean="0"/>
              <a:t>2022/3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5814BFC-4E47-4761-973C-A844E44F03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91B7ADB-02AC-4E3A-A1AA-BCFF8F9E29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42898-05B2-4BEA-BD12-7BF21AF849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34728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D7DC4AC-7621-42FA-A674-FBF38DE503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08CA22C8-0878-49D2-870B-20291972B60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AC2E344-5312-467B-9C21-29B5DCDA0A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0EA48E1-F699-4D9A-9828-2146A11E59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B3624F-0771-4BFC-893F-5FA64BEFACAA}" type="datetimeFigureOut">
              <a:rPr kumimoji="1" lang="ja-JP" altLang="en-US" smtClean="0"/>
              <a:t>2022/3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E748242-C2C3-4AAD-8065-2005A5EE20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D63E6BE-F1E4-4BEE-A010-B79877D536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42898-05B2-4BEA-BD12-7BF21AF849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39064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89388D56-8DE7-48DF-908C-283FE006A1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49D98A3-7AFC-419E-8886-F31B963F59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44483C6-B904-434B-A1B6-72333F2E657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B3624F-0771-4BFC-893F-5FA64BEFACAA}" type="datetimeFigureOut">
              <a:rPr kumimoji="1" lang="ja-JP" altLang="en-US" smtClean="0"/>
              <a:t>2022/3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6AC4534-8967-4487-86E5-89CDC346E80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91B8A87-3A00-480E-839A-B11CCCD9281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342898-05B2-4BEA-BD12-7BF21AF849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82722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コンテンツ プレースホルダー 3">
            <a:extLst>
              <a:ext uri="{FF2B5EF4-FFF2-40B4-BE49-F238E27FC236}">
                <a16:creationId xmlns:a16="http://schemas.microsoft.com/office/drawing/2014/main" id="{798BEF20-1EB7-474D-A29C-6A31978F3128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117397838"/>
              </p:ext>
            </p:extLst>
          </p:nvPr>
        </p:nvGraphicFramePr>
        <p:xfrm>
          <a:off x="606424" y="1287939"/>
          <a:ext cx="10252076" cy="485493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4301750">
                  <a:extLst>
                    <a:ext uri="{9D8B030D-6E8A-4147-A177-3AD203B41FA5}">
                      <a16:colId xmlns:a16="http://schemas.microsoft.com/office/drawing/2014/main" val="4220040182"/>
                    </a:ext>
                  </a:extLst>
                </a:gridCol>
                <a:gridCol w="1983442">
                  <a:extLst>
                    <a:ext uri="{9D8B030D-6E8A-4147-A177-3AD203B41FA5}">
                      <a16:colId xmlns:a16="http://schemas.microsoft.com/office/drawing/2014/main" val="3185045030"/>
                    </a:ext>
                  </a:extLst>
                </a:gridCol>
                <a:gridCol w="1983442">
                  <a:extLst>
                    <a:ext uri="{9D8B030D-6E8A-4147-A177-3AD203B41FA5}">
                      <a16:colId xmlns:a16="http://schemas.microsoft.com/office/drawing/2014/main" val="3062484107"/>
                    </a:ext>
                  </a:extLst>
                </a:gridCol>
                <a:gridCol w="1983442">
                  <a:extLst>
                    <a:ext uri="{9D8B030D-6E8A-4147-A177-3AD203B41FA5}">
                      <a16:colId xmlns:a16="http://schemas.microsoft.com/office/drawing/2014/main" val="4102580460"/>
                    </a:ext>
                  </a:extLst>
                </a:gridCol>
              </a:tblGrid>
              <a:tr h="334120">
                <a:tc>
                  <a:txBody>
                    <a:bodyPr/>
                    <a:lstStyle/>
                    <a:p>
                      <a:pPr algn="ctr" fontAlgn="b"/>
                      <a:endParaRPr lang="ja-JP" alt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psychotic</a:t>
                      </a:r>
                    </a:p>
                    <a:p>
                      <a:pPr algn="ctr" fontAlgn="b"/>
                      <a:r>
                        <a:rPr lang="en-US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-dose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psychotic</a:t>
                      </a:r>
                    </a:p>
                    <a:p>
                      <a:pPr algn="ctr" fontAlgn="b"/>
                      <a:r>
                        <a:rPr lang="en-US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-dose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0478572"/>
                  </a:ext>
                </a:extLst>
              </a:tr>
              <a:tr h="334120"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periden (yes/no)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2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0/1255</a:t>
                      </a:r>
                      <a:endParaRPr lang="en-US" altLang="ja-JP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3/279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2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.7 × 10</a:t>
                      </a:r>
                      <a:r>
                        <a:rPr kumimoji="1" lang="en-US" altLang="ja-JP" sz="2000" kern="1200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7</a:t>
                      </a:r>
                      <a:endParaRPr kumimoji="1" lang="ja-JP" altLang="ja-JP" sz="20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613322678"/>
                  </a:ext>
                </a:extLst>
              </a:tr>
              <a:tr h="334120"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hexyphenidyl (yes/no)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2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/1549</a:t>
                      </a:r>
                      <a:endParaRPr lang="en-US" altLang="ja-JP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2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/391</a:t>
                      </a:r>
                      <a:endParaRPr lang="en-US" altLang="ja-JP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0</a:t>
                      </a:r>
                      <a:r>
                        <a:rPr kumimoji="1" lang="en-US" altLang="ja-JP" sz="2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× 10</a:t>
                      </a:r>
                      <a:r>
                        <a:rPr kumimoji="1" lang="en-US" altLang="ja-JP" sz="2000" kern="1200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4</a:t>
                      </a:r>
                      <a:endParaRPr kumimoji="1" lang="ja-JP" altLang="ja-JP" sz="20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681532103"/>
                  </a:ext>
                </a:extLst>
              </a:tr>
              <a:tr h="334120"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methazine (yes/no)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2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/1558</a:t>
                      </a:r>
                      <a:endParaRPr lang="en-US" altLang="ja-JP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2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/401</a:t>
                      </a:r>
                      <a:endParaRPr lang="en-US" altLang="ja-JP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7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94153512"/>
                  </a:ext>
                </a:extLst>
              </a:tr>
              <a:tr h="499324">
                <a:tc>
                  <a:txBody>
                    <a:bodyPr/>
                    <a:lstStyle/>
                    <a:p>
                      <a:pPr algn="ctr" fontAlgn="b"/>
                      <a:endParaRPr lang="ja-JP" alt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psychotic Monotherapy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psychotic polypharmacy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5153755"/>
                  </a:ext>
                </a:extLst>
              </a:tr>
              <a:tr h="334120"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periden (yes/no)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9/935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4/599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 × 10</a:t>
                      </a:r>
                      <a:r>
                        <a:rPr kumimoji="1" lang="en-US" altLang="ja-JP" sz="2000" kern="1200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15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234562657"/>
                  </a:ext>
                </a:extLst>
              </a:tr>
              <a:tr h="334120"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hexyphenidyl (yes/no)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2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/1109</a:t>
                      </a:r>
                      <a:endParaRPr lang="en-US" altLang="ja-JP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2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/832</a:t>
                      </a:r>
                      <a:endParaRPr lang="en-US" altLang="ja-JP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 × 10</a:t>
                      </a:r>
                      <a:r>
                        <a:rPr kumimoji="1" lang="en-US" altLang="ja-JP" sz="2000" kern="1200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7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983608170"/>
                  </a:ext>
                </a:extLst>
              </a:tr>
              <a:tr h="334120"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methazine (yes/no)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/1110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/849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9 × 10</a:t>
                      </a:r>
                      <a:r>
                        <a:rPr kumimoji="1" lang="en-US" altLang="ja-JP" sz="2000" kern="1200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4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14553026"/>
                  </a:ext>
                </a:extLst>
              </a:tr>
              <a:tr h="499324">
                <a:tc>
                  <a:txBody>
                    <a:bodyPr/>
                    <a:lstStyle/>
                    <a:p>
                      <a:pPr algn="ctr" fontAlgn="b"/>
                      <a:endParaRPr lang="ja-JP" alt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GA monotherapy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A monotherapy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905875"/>
                  </a:ext>
                </a:extLst>
              </a:tr>
              <a:tr h="334120"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periden (yes/no)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2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6/889</a:t>
                      </a:r>
                      <a:endParaRPr lang="en-US" altLang="ja-JP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2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/46</a:t>
                      </a:r>
                      <a:endParaRPr lang="en-US" altLang="ja-JP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4 × 10</a:t>
                      </a:r>
                      <a:r>
                        <a:rPr kumimoji="1" lang="en-US" altLang="ja-JP" sz="2000" kern="1200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9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504277265"/>
                  </a:ext>
                </a:extLst>
              </a:tr>
              <a:tr h="334120"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hexyphenidyl (yes/no)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2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/1040</a:t>
                      </a:r>
                      <a:endParaRPr lang="en-US" altLang="ja-JP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2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/69</a:t>
                      </a:r>
                      <a:endParaRPr lang="en-US" altLang="ja-JP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4 × 10</a:t>
                      </a:r>
                      <a:r>
                        <a:rPr kumimoji="1" lang="en-US" altLang="ja-JP" sz="2000" kern="1200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11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713039762"/>
                  </a:ext>
                </a:extLst>
              </a:tr>
              <a:tr h="334120"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methazine (yes/no)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/1037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/73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 × 10</a:t>
                      </a:r>
                      <a:r>
                        <a:rPr kumimoji="1" lang="en-US" altLang="ja-JP" sz="2000" kern="1200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4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21858677"/>
                  </a:ext>
                </a:extLst>
              </a:tr>
            </a:tbl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60AF4B24-E1D9-4A49-B410-BD5FD417161E}"/>
              </a:ext>
            </a:extLst>
          </p:cNvPr>
          <p:cNvSpPr txBox="1"/>
          <p:nvPr/>
        </p:nvSpPr>
        <p:spPr>
          <a:xfrm>
            <a:off x="77529" y="188063"/>
            <a:ext cx="20479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(Supple Table 1)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470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85F7567-ED5E-432B-B9E8-AD3E7C0470D8}"/>
              </a:ext>
            </a:extLst>
          </p:cNvPr>
          <p:cNvSpPr txBox="1"/>
          <p:nvPr/>
        </p:nvSpPr>
        <p:spPr>
          <a:xfrm>
            <a:off x="134679" y="616688"/>
            <a:ext cx="18605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Supple Table 2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3F2FDC1B-20CD-447E-8276-77221D45FBC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02875961"/>
              </p:ext>
            </p:extLst>
          </p:nvPr>
        </p:nvGraphicFramePr>
        <p:xfrm>
          <a:off x="390524" y="1725454"/>
          <a:ext cx="11420476" cy="3662680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115127">
                  <a:extLst>
                    <a:ext uri="{9D8B030D-6E8A-4147-A177-3AD203B41FA5}">
                      <a16:colId xmlns:a16="http://schemas.microsoft.com/office/drawing/2014/main" val="805745527"/>
                    </a:ext>
                  </a:extLst>
                </a:gridCol>
                <a:gridCol w="1115127">
                  <a:extLst>
                    <a:ext uri="{9D8B030D-6E8A-4147-A177-3AD203B41FA5}">
                      <a16:colId xmlns:a16="http://schemas.microsoft.com/office/drawing/2014/main" val="518965386"/>
                    </a:ext>
                  </a:extLst>
                </a:gridCol>
                <a:gridCol w="1115127">
                  <a:extLst>
                    <a:ext uri="{9D8B030D-6E8A-4147-A177-3AD203B41FA5}">
                      <a16:colId xmlns:a16="http://schemas.microsoft.com/office/drawing/2014/main" val="1933067308"/>
                    </a:ext>
                  </a:extLst>
                </a:gridCol>
                <a:gridCol w="1115127">
                  <a:extLst>
                    <a:ext uri="{9D8B030D-6E8A-4147-A177-3AD203B41FA5}">
                      <a16:colId xmlns:a16="http://schemas.microsoft.com/office/drawing/2014/main" val="1064051760"/>
                    </a:ext>
                  </a:extLst>
                </a:gridCol>
                <a:gridCol w="1115127">
                  <a:extLst>
                    <a:ext uri="{9D8B030D-6E8A-4147-A177-3AD203B41FA5}">
                      <a16:colId xmlns:a16="http://schemas.microsoft.com/office/drawing/2014/main" val="2143481713"/>
                    </a:ext>
                  </a:extLst>
                </a:gridCol>
                <a:gridCol w="1115127">
                  <a:extLst>
                    <a:ext uri="{9D8B030D-6E8A-4147-A177-3AD203B41FA5}">
                      <a16:colId xmlns:a16="http://schemas.microsoft.com/office/drawing/2014/main" val="1020028809"/>
                    </a:ext>
                  </a:extLst>
                </a:gridCol>
                <a:gridCol w="1392049">
                  <a:extLst>
                    <a:ext uri="{9D8B030D-6E8A-4147-A177-3AD203B41FA5}">
                      <a16:colId xmlns:a16="http://schemas.microsoft.com/office/drawing/2014/main" val="143945285"/>
                    </a:ext>
                  </a:extLst>
                </a:gridCol>
                <a:gridCol w="3337665">
                  <a:extLst>
                    <a:ext uri="{9D8B030D-6E8A-4147-A177-3AD203B41FA5}">
                      <a16:colId xmlns:a16="http://schemas.microsoft.com/office/drawing/2014/main" val="3277936876"/>
                    </a:ext>
                  </a:extLst>
                </a:gridCol>
              </a:tblGrid>
              <a:tr h="228600"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-dose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-dose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07264715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G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G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G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G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G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G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t hoc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33789862"/>
                  </a:ext>
                </a:extLst>
              </a:tr>
              <a:tr h="6858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 ± 0.6</a:t>
                      </a:r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 ± 1.2</a:t>
                      </a:r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 ± 1.6</a:t>
                      </a:r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 ± 1.1</a:t>
                      </a:r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 ± 1.9</a:t>
                      </a:r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 ± 2.1</a:t>
                      </a:r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 × 10</a:t>
                      </a:r>
                      <a:r>
                        <a:rPr kumimoji="1" lang="en-US" altLang="ja-JP" sz="1600" kern="1200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54</a:t>
                      </a:r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G(Normal)&lt;MG(Normal)=LG(High)&lt;HG(Noral)=MG(High)&lt;HG(High)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542385762"/>
                  </a:ext>
                </a:extLst>
              </a:tr>
              <a:tr h="219551"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psychotic Monotherapy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psychotic Polypharmacy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66347642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G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G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G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G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G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G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t hoc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7156085"/>
                  </a:ext>
                </a:extLst>
              </a:tr>
              <a:tr h="9144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 ± 0.6</a:t>
                      </a:r>
                      <a:endParaRPr lang="en-US" altLang="ja-JP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 ± 1.1</a:t>
                      </a:r>
                      <a:endParaRPr lang="en-US" altLang="ja-JP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 ± 1.6</a:t>
                      </a:r>
                      <a:endParaRPr lang="en-US" altLang="ja-JP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 ± 1.0</a:t>
                      </a:r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 ± 1.6</a:t>
                      </a:r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 ± 1.9</a:t>
                      </a:r>
                      <a:endParaRPr lang="en-US" altLang="ja-JP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×10</a:t>
                      </a:r>
                      <a:r>
                        <a:rPr kumimoji="1" lang="en-US" altLang="ja-JP" sz="1600" kern="1200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55</a:t>
                      </a:r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G(Mono)&lt;MG(mono)&lt;HG(Mono)=MG (Poly)&lt;HG(Poly)</a:t>
                      </a:r>
                      <a:br>
                        <a:rPr lang="en-US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G(Poly)&lt;HG(mono)=MG(Poly)&lt;HG(Poly)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483052291"/>
                  </a:ext>
                </a:extLst>
              </a:tr>
              <a:tr h="228600"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GA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A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117024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G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G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G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G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G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G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t hoc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66526684"/>
                  </a:ext>
                </a:extLst>
              </a:tr>
              <a:tr h="4572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 ± 0.5</a:t>
                      </a:r>
                      <a:endParaRPr lang="en-US" altLang="ja-JP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 ± 1.1</a:t>
                      </a:r>
                      <a:endParaRPr lang="en-US" altLang="ja-JP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 ± 1.5</a:t>
                      </a:r>
                      <a:endParaRPr lang="en-US" altLang="ja-JP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 ± 1.1</a:t>
                      </a:r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 ± 1.8</a:t>
                      </a:r>
                      <a:endParaRPr lang="en-US" altLang="ja-JP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 ± 1.9</a:t>
                      </a:r>
                      <a:endParaRPr lang="en-US" altLang="ja-JP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×10</a:t>
                      </a:r>
                      <a:r>
                        <a:rPr kumimoji="1" lang="en-US" altLang="ja-JP" sz="1600" kern="1200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4</a:t>
                      </a:r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G(SGA)&lt;MG(SGA)&lt;HG(SGA)=MG(FGA)&lt;HG(FGA)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11763108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25340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3</TotalTime>
  <Words>297</Words>
  <Application>Microsoft Office PowerPoint</Application>
  <PresentationFormat>ワイド画面</PresentationFormat>
  <Paragraphs>103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堀 輝</dc:creator>
  <cp:lastModifiedBy>堀 輝</cp:lastModifiedBy>
  <cp:revision>5</cp:revision>
  <dcterms:created xsi:type="dcterms:W3CDTF">2022-03-13T13:38:10Z</dcterms:created>
  <dcterms:modified xsi:type="dcterms:W3CDTF">2022-03-22T09:53:44Z</dcterms:modified>
</cp:coreProperties>
</file>